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omments/modernComment_107_7F34F39C.xml" ContentType="application/vnd.ms-powerpoint.comments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E94806F5-F1DD-79F5-3D8D-85F6927CF9C2}" name="Author" initials="A" userId="Author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18" autoAdjust="0"/>
    <p:restoredTop sz="94660"/>
  </p:normalViewPr>
  <p:slideViewPr>
    <p:cSldViewPr snapToGrid="0">
      <p:cViewPr varScale="1">
        <p:scale>
          <a:sx n="64" d="100"/>
          <a:sy n="64" d="100"/>
        </p:scale>
        <p:origin x="102" y="24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笠井 高士" userId="b739b569911c36d1" providerId="LiveId" clId="{BBFC975D-9B13-43B1-BA95-8C97FB216E64}"/>
    <pc:docChg chg="modSld">
      <pc:chgData name="笠井 高士" userId="b739b569911c36d1" providerId="LiveId" clId="{BBFC975D-9B13-43B1-BA95-8C97FB216E64}" dt="2022-12-30T04:09:14.364" v="4" actId="207"/>
      <pc:docMkLst>
        <pc:docMk/>
      </pc:docMkLst>
      <pc:sldChg chg="modSp mod">
        <pc:chgData name="笠井 高士" userId="b739b569911c36d1" providerId="LiveId" clId="{BBFC975D-9B13-43B1-BA95-8C97FB216E64}" dt="2022-12-30T00:51:06.182" v="1" actId="207"/>
        <pc:sldMkLst>
          <pc:docMk/>
          <pc:sldMk cId="2134176668" sldId="263"/>
        </pc:sldMkLst>
        <pc:spChg chg="mod">
          <ac:chgData name="笠井 高士" userId="b739b569911c36d1" providerId="LiveId" clId="{BBFC975D-9B13-43B1-BA95-8C97FB216E64}" dt="2022-12-30T00:50:57.433" v="0" actId="207"/>
          <ac:spMkLst>
            <pc:docMk/>
            <pc:sldMk cId="2134176668" sldId="263"/>
            <ac:spMk id="4" creationId="{F1D474B2-8746-4B43-9085-4DA4743C89EA}"/>
          </ac:spMkLst>
        </pc:spChg>
        <pc:spChg chg="mod">
          <ac:chgData name="笠井 高士" userId="b739b569911c36d1" providerId="LiveId" clId="{BBFC975D-9B13-43B1-BA95-8C97FB216E64}" dt="2022-12-30T00:51:06.182" v="1" actId="207"/>
          <ac:spMkLst>
            <pc:docMk/>
            <pc:sldMk cId="2134176668" sldId="263"/>
            <ac:spMk id="5" creationId="{F98E99C1-AB22-4DB7-9DCE-AC0F396D1B96}"/>
          </ac:spMkLst>
        </pc:spChg>
      </pc:sldChg>
      <pc:sldChg chg="modSp mod">
        <pc:chgData name="笠井 高士" userId="b739b569911c36d1" providerId="LiveId" clId="{BBFC975D-9B13-43B1-BA95-8C97FB216E64}" dt="2022-12-30T04:09:14.364" v="4" actId="207"/>
        <pc:sldMkLst>
          <pc:docMk/>
          <pc:sldMk cId="1641490721" sldId="264"/>
        </pc:sldMkLst>
        <pc:spChg chg="mod">
          <ac:chgData name="笠井 高士" userId="b739b569911c36d1" providerId="LiveId" clId="{BBFC975D-9B13-43B1-BA95-8C97FB216E64}" dt="2022-12-30T04:09:02.636" v="2" actId="207"/>
          <ac:spMkLst>
            <pc:docMk/>
            <pc:sldMk cId="1641490721" sldId="264"/>
            <ac:spMk id="4" creationId="{F1D474B2-8746-4B43-9085-4DA4743C89EA}"/>
          </ac:spMkLst>
        </pc:spChg>
        <pc:spChg chg="mod">
          <ac:chgData name="笠井 高士" userId="b739b569911c36d1" providerId="LiveId" clId="{BBFC975D-9B13-43B1-BA95-8C97FB216E64}" dt="2022-12-30T04:09:10.509" v="3" actId="207"/>
          <ac:spMkLst>
            <pc:docMk/>
            <pc:sldMk cId="1641490721" sldId="264"/>
            <ac:spMk id="5" creationId="{F98E99C1-AB22-4DB7-9DCE-AC0F396D1B96}"/>
          </ac:spMkLst>
        </pc:spChg>
        <pc:spChg chg="mod">
          <ac:chgData name="笠井 高士" userId="b739b569911c36d1" providerId="LiveId" clId="{BBFC975D-9B13-43B1-BA95-8C97FB216E64}" dt="2022-12-30T04:09:14.364" v="4" actId="207"/>
          <ac:spMkLst>
            <pc:docMk/>
            <pc:sldMk cId="1641490721" sldId="264"/>
            <ac:spMk id="12" creationId="{8B8F1A30-F3A4-3BF7-191D-CA0FD7933684}"/>
          </ac:spMkLst>
        </pc:spChg>
      </pc:sldChg>
    </pc:docChg>
  </pc:docChgLst>
  <pc:docChgLst>
    <pc:chgData name="笠井 高士" userId="b739b569911c36d1" providerId="LiveId" clId="{2BC72172-4C4B-4F4A-9A7C-9C8728C64031}"/>
    <pc:docChg chg="undo custSel modSld">
      <pc:chgData name="笠井 高士" userId="b739b569911c36d1" providerId="LiveId" clId="{2BC72172-4C4B-4F4A-9A7C-9C8728C64031}" dt="2023-01-21T06:51:11.337" v="310" actId="1076"/>
      <pc:docMkLst>
        <pc:docMk/>
      </pc:docMkLst>
      <pc:sldChg chg="addSp modSp mod">
        <pc:chgData name="笠井 高士" userId="b739b569911c36d1" providerId="LiveId" clId="{2BC72172-4C4B-4F4A-9A7C-9C8728C64031}" dt="2023-01-21T06:51:11.337" v="310" actId="1076"/>
        <pc:sldMkLst>
          <pc:docMk/>
          <pc:sldMk cId="1641490721" sldId="264"/>
        </pc:sldMkLst>
        <pc:spChg chg="mod">
          <ac:chgData name="笠井 高士" userId="b739b569911c36d1" providerId="LiveId" clId="{2BC72172-4C4B-4F4A-9A7C-9C8728C64031}" dt="2023-01-21T01:41:42.122" v="295" actId="1076"/>
          <ac:spMkLst>
            <pc:docMk/>
            <pc:sldMk cId="1641490721" sldId="264"/>
            <ac:spMk id="5" creationId="{F98E99C1-AB22-4DB7-9DCE-AC0F396D1B96}"/>
          </ac:spMkLst>
        </pc:spChg>
        <pc:spChg chg="mod">
          <ac:chgData name="笠井 高士" userId="b739b569911c36d1" providerId="LiveId" clId="{2BC72172-4C4B-4F4A-9A7C-9C8728C64031}" dt="2023-01-21T01:41:37.205" v="294" actId="1036"/>
          <ac:spMkLst>
            <pc:docMk/>
            <pc:sldMk cId="1641490721" sldId="264"/>
            <ac:spMk id="7" creationId="{F20E57A0-67A4-3686-840E-F60302F2400F}"/>
          </ac:spMkLst>
        </pc:spChg>
        <pc:spChg chg="mod">
          <ac:chgData name="笠井 高士" userId="b739b569911c36d1" providerId="LiveId" clId="{2BC72172-4C4B-4F4A-9A7C-9C8728C64031}" dt="2023-01-21T01:41:37.205" v="294" actId="1036"/>
          <ac:spMkLst>
            <pc:docMk/>
            <pc:sldMk cId="1641490721" sldId="264"/>
            <ac:spMk id="8" creationId="{3AA9B300-F6D4-1D0B-24BD-42942B528058}"/>
          </ac:spMkLst>
        </pc:spChg>
        <pc:spChg chg="mod">
          <ac:chgData name="笠井 高士" userId="b739b569911c36d1" providerId="LiveId" clId="{2BC72172-4C4B-4F4A-9A7C-9C8728C64031}" dt="2023-01-21T01:41:37.205" v="294" actId="1036"/>
          <ac:spMkLst>
            <pc:docMk/>
            <pc:sldMk cId="1641490721" sldId="264"/>
            <ac:spMk id="9" creationId="{BF1C3297-34DB-8DB7-62CE-2DA58BC60026}"/>
          </ac:spMkLst>
        </pc:spChg>
        <pc:spChg chg="mod">
          <ac:chgData name="笠井 高士" userId="b739b569911c36d1" providerId="LiveId" clId="{2BC72172-4C4B-4F4A-9A7C-9C8728C64031}" dt="2023-01-21T01:41:37.205" v="294" actId="1036"/>
          <ac:spMkLst>
            <pc:docMk/>
            <pc:sldMk cId="1641490721" sldId="264"/>
            <ac:spMk id="11" creationId="{F0ADF4F3-F362-3C16-27B4-2A1CB60AF4DE}"/>
          </ac:spMkLst>
        </pc:spChg>
        <pc:spChg chg="mod">
          <ac:chgData name="笠井 高士" userId="b739b569911c36d1" providerId="LiveId" clId="{2BC72172-4C4B-4F4A-9A7C-9C8728C64031}" dt="2023-01-21T01:41:37.205" v="294" actId="1036"/>
          <ac:spMkLst>
            <pc:docMk/>
            <pc:sldMk cId="1641490721" sldId="264"/>
            <ac:spMk id="12" creationId="{8B8F1A30-F3A4-3BF7-191D-CA0FD7933684}"/>
          </ac:spMkLst>
        </pc:spChg>
        <pc:spChg chg="add mod">
          <ac:chgData name="笠井 高士" userId="b739b569911c36d1" providerId="LiveId" clId="{2BC72172-4C4B-4F4A-9A7C-9C8728C64031}" dt="2023-01-21T01:41:37.205" v="294" actId="1036"/>
          <ac:spMkLst>
            <pc:docMk/>
            <pc:sldMk cId="1641490721" sldId="264"/>
            <ac:spMk id="14" creationId="{B75016E2-91EB-6DF9-CF96-E94600554DDF}"/>
          </ac:spMkLst>
        </pc:spChg>
        <pc:graphicFrameChg chg="mod">
          <ac:chgData name="笠井 高士" userId="b739b569911c36d1" providerId="LiveId" clId="{2BC72172-4C4B-4F4A-9A7C-9C8728C64031}" dt="2023-01-21T06:51:10.033" v="309" actId="1076"/>
          <ac:graphicFrameMkLst>
            <pc:docMk/>
            <pc:sldMk cId="1641490721" sldId="264"/>
            <ac:graphicFrameMk id="2" creationId="{F243205E-C48C-488E-1A26-EFE92C3C71D3}"/>
          </ac:graphicFrameMkLst>
        </pc:graphicFrameChg>
        <pc:graphicFrameChg chg="mod">
          <ac:chgData name="笠井 高士" userId="b739b569911c36d1" providerId="LiveId" clId="{2BC72172-4C4B-4F4A-9A7C-9C8728C64031}" dt="2023-01-21T06:50:08.816" v="297" actId="1076"/>
          <ac:graphicFrameMkLst>
            <pc:docMk/>
            <pc:sldMk cId="1641490721" sldId="264"/>
            <ac:graphicFrameMk id="3" creationId="{238C4FEB-A0A9-5CEF-FD83-FB8087A4B7A8}"/>
          </ac:graphicFrameMkLst>
        </pc:graphicFrameChg>
        <pc:graphicFrameChg chg="mod">
          <ac:chgData name="笠井 高士" userId="b739b569911c36d1" providerId="LiveId" clId="{2BC72172-4C4B-4F4A-9A7C-9C8728C64031}" dt="2023-01-21T06:50:19.641" v="299" actId="14100"/>
          <ac:graphicFrameMkLst>
            <pc:docMk/>
            <pc:sldMk cId="1641490721" sldId="264"/>
            <ac:graphicFrameMk id="6" creationId="{9F089E6E-299B-D390-6B0E-484D2EA2A026}"/>
          </ac:graphicFrameMkLst>
        </pc:graphicFrameChg>
        <pc:graphicFrameChg chg="mod">
          <ac:chgData name="笠井 高士" userId="b739b569911c36d1" providerId="LiveId" clId="{2BC72172-4C4B-4F4A-9A7C-9C8728C64031}" dt="2023-01-21T06:51:11.337" v="310" actId="1076"/>
          <ac:graphicFrameMkLst>
            <pc:docMk/>
            <pc:sldMk cId="1641490721" sldId="264"/>
            <ac:graphicFrameMk id="10" creationId="{99D1927E-8240-54E0-14D1-4325850638F8}"/>
          </ac:graphicFrameMkLst>
        </pc:graphicFrameChg>
        <pc:graphicFrameChg chg="add mod">
          <ac:chgData name="笠井 高士" userId="b739b569911c36d1" providerId="LiveId" clId="{2BC72172-4C4B-4F4A-9A7C-9C8728C64031}" dt="2023-01-21T06:50:30.804" v="301" actId="1076"/>
          <ac:graphicFrameMkLst>
            <pc:docMk/>
            <pc:sldMk cId="1641490721" sldId="264"/>
            <ac:graphicFrameMk id="13" creationId="{EA5AB24F-0F96-3B27-4167-38BB5B552436}"/>
          </ac:graphicFrameMkLst>
        </pc:graphicFrameChg>
      </pc:sldChg>
    </pc:docChg>
  </pc:docChgLst>
</pc:chgInfo>
</file>

<file path=ppt/comments/modernComment_107_7F34F39C.xml><?xml version="1.0" encoding="utf-8"?>
<p188:cmLst xmlns:a="http://schemas.openxmlformats.org/drawingml/2006/main" xmlns:r="http://schemas.openxmlformats.org/officeDocument/2006/relationships" xmlns:p188="http://schemas.microsoft.com/office/powerpoint/2018/8/main">
  <p188:cm id="{40E8C432-DDF3-4705-9742-828AD3CDFA61}" authorId="{E94806F5-F1DD-79F5-3D8D-85F6927CF9C2}" created="2022-12-26T02:05:31.486">
    <pc:sldMkLst xmlns:pc="http://schemas.microsoft.com/office/powerpoint/2013/main/command">
      <pc:docMk/>
      <pc:sldMk cId="2134176668" sldId="263"/>
    </pc:sldMkLst>
    <p188:txBody>
      <a:bodyPr/>
      <a:lstStyle/>
      <a:p>
        <a:r>
          <a:rPr lang="en-US"/>
          <a:t>At the authors' discretion, I might recommend revising the ROC heading to 'LRG levels in PD vs controls.' I also recommend presenting the figures in a standardized font such as Times New Roman or Arial.</a:t>
        </a:r>
      </a:p>
    </p188:txBody>
  </p188:cm>
</p188:cmLst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A9F9342-480D-4AB6-A8E9-6BA7628F797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B5362AA7-77A6-4994-B024-A2E765F2AA1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4FE86D4-82BE-4526-B656-E8D7A7F308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123E5-B5FA-4208-A985-F5A9E10EC874}" type="datetimeFigureOut">
              <a:rPr kumimoji="1" lang="ja-JP" altLang="en-US" smtClean="0"/>
              <a:t>2023/2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DCCCE04-7CCF-404A-A759-C10802EDA5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1E1A051-6060-4722-893F-03367777CB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8C3E5-6CF1-4A14-B3D5-18FCBFFCC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59420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6178190-71C3-48C5-99E3-9A33B393FA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1EFF568-9CE5-482A-8424-1BB14A69EED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F8C4672-3C15-4D90-857E-8DCB1CD94A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123E5-B5FA-4208-A985-F5A9E10EC874}" type="datetimeFigureOut">
              <a:rPr kumimoji="1" lang="ja-JP" altLang="en-US" smtClean="0"/>
              <a:t>2023/2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5F26533-DCC4-4DE3-A767-4E443094B6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9FFD0F3-51DD-44FE-BD6B-7009119068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8C3E5-6CF1-4A14-B3D5-18FCBFFCC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57349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919DA1A3-9FAA-4F89-A0F3-F7E58C10AD0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47626A0-44F9-4A58-AC7C-6BEE35C3D82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88F63BA-3542-409C-9B98-3DEC454070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123E5-B5FA-4208-A985-F5A9E10EC874}" type="datetimeFigureOut">
              <a:rPr kumimoji="1" lang="ja-JP" altLang="en-US" smtClean="0"/>
              <a:t>2023/2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BE8AE5F-071D-4E30-9150-7B3DB74632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CE07C92-8FEC-4D1E-BFB7-C686D1AE69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8C3E5-6CF1-4A14-B3D5-18FCBFFCC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85478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52E5299-4A95-4CF6-83AE-7A97D8D057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31F919D-86A6-42F5-A205-84046E9003F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39DE45F-9944-4819-85AB-F0360F980B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123E5-B5FA-4208-A985-F5A9E10EC874}" type="datetimeFigureOut">
              <a:rPr kumimoji="1" lang="ja-JP" altLang="en-US" smtClean="0"/>
              <a:t>2023/2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2B32846-680D-4909-A5B1-7EADD2CF5D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41B8C48-4F99-4EC4-8906-56341F2F95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8C3E5-6CF1-4A14-B3D5-18FCBFFCC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17096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711F587-4158-4281-B5A7-059B684162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F8CD6E4-631D-4554-AE79-757EF354B6E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E497F7D-D853-45CF-A79D-E67E018F34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123E5-B5FA-4208-A985-F5A9E10EC874}" type="datetimeFigureOut">
              <a:rPr kumimoji="1" lang="ja-JP" altLang="en-US" smtClean="0"/>
              <a:t>2023/2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ABEE5CA-3B5D-4C7C-9CF9-213F11424D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E7F87B4-C222-4717-B6C2-DC10B65CD5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8C3E5-6CF1-4A14-B3D5-18FCBFFCC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35720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ECAD35D-C11A-437F-96D0-48A7674A0B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A47FD68-B723-4A12-94C6-E6D6B8A64BB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F3386AC-7378-49FB-96AA-FEADEE900A1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E1014B0-413A-4E28-A923-205BCB83DA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123E5-B5FA-4208-A985-F5A9E10EC874}" type="datetimeFigureOut">
              <a:rPr kumimoji="1" lang="ja-JP" altLang="en-US" smtClean="0"/>
              <a:t>2023/2/1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4FDEF19-5497-4554-BA05-515FB66796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A266CA1-B4CA-4D30-AEF8-41457765BB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8C3E5-6CF1-4A14-B3D5-18FCBFFCC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09271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E633FCF-1A8D-4BFA-84FB-F4AD8F8D68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08CFA5F-5E66-499C-8A1B-77827573E2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7D78E87-F3A4-47C3-8EA3-037431C4462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88C3CE1F-856C-49BA-BB46-C3C2612589C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52EBF08D-3156-47B0-8545-0CE547DF5B2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CFEBD36C-73A6-4D58-BAF5-548206F4A5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123E5-B5FA-4208-A985-F5A9E10EC874}" type="datetimeFigureOut">
              <a:rPr kumimoji="1" lang="ja-JP" altLang="en-US" smtClean="0"/>
              <a:t>2023/2/15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74FE0F4F-1802-45F9-BB94-AA5CBE3BB1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A18342BC-EE7B-4346-8813-4188F115BF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8C3E5-6CF1-4A14-B3D5-18FCBFFCC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75096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8B4075D-128D-415B-BF3A-88BAA9BD35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45AC8B7F-0DF3-4C45-B47B-DDC1403184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123E5-B5FA-4208-A985-F5A9E10EC874}" type="datetimeFigureOut">
              <a:rPr kumimoji="1" lang="ja-JP" altLang="en-US" smtClean="0"/>
              <a:t>2023/2/15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9792D249-4F38-4E90-9EB7-A4096C44F1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7E6982EA-BAD1-4147-9C46-8F7C29BF84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8C3E5-6CF1-4A14-B3D5-18FCBFFCC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46010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BE6C7F17-ECAB-4611-8FDA-8A26B8BE6C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123E5-B5FA-4208-A985-F5A9E10EC874}" type="datetimeFigureOut">
              <a:rPr kumimoji="1" lang="ja-JP" altLang="en-US" smtClean="0"/>
              <a:t>2023/2/15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81F7FB2A-0B70-4691-A851-0E5D205FF0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8E2051C2-4E05-4667-8369-C6AE71609F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8C3E5-6CF1-4A14-B3D5-18FCBFFCC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69006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94F6D01-2353-4AE2-AF66-7344B40830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A819385-9AF4-419F-BE0F-6E9620CD687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BE3AB37-CE72-460C-9C2E-D3DAFC6800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646568B-8AD4-49CB-B057-67C091ECC7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123E5-B5FA-4208-A985-F5A9E10EC874}" type="datetimeFigureOut">
              <a:rPr kumimoji="1" lang="ja-JP" altLang="en-US" smtClean="0"/>
              <a:t>2023/2/1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F64079F-24FB-4A26-8D1E-7AB4BA8AA9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FB311E3-ED29-43ED-928D-BDA26161EF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8C3E5-6CF1-4A14-B3D5-18FCBFFCC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30337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83A1443-2BAB-4B03-B0A6-CD5A5100A0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36E744CD-0FF8-48C4-AB2D-B264A48EE29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9CC2F75-00AC-4946-A534-D698B6FAA37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82F6DDF-5C2C-4347-B294-11A42971CF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123E5-B5FA-4208-A985-F5A9E10EC874}" type="datetimeFigureOut">
              <a:rPr kumimoji="1" lang="ja-JP" altLang="en-US" smtClean="0"/>
              <a:t>2023/2/1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925D9C3-7FC0-440C-B8C8-1CD14B09D3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C2E728E-5FD7-4D5D-9C8A-92138193ED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8C3E5-6CF1-4A14-B3D5-18FCBFFCC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46439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C83FEC5D-9F32-4C48-97C5-0D8D565E23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16C7C8E-E50C-40DD-96BE-D29EA95B0C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FE14744-9BBF-4779-A770-C623501F93F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B123E5-B5FA-4208-A985-F5A9E10EC874}" type="datetimeFigureOut">
              <a:rPr kumimoji="1" lang="ja-JP" altLang="en-US" smtClean="0"/>
              <a:t>2023/2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F3F4579-CB4E-47F4-BEC7-E2206FAA6A6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AC86143-05AF-4DE3-B1CE-E1E3B864AC1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68C3E5-6CF1-4A14-B3D5-18FCBFFCC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67122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microsoft.com/office/2018/10/relationships/comments" Target="../comments/modernComment_107_7F34F39C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1D474B2-8746-4B43-9085-4DA4743C89EA}"/>
              </a:ext>
            </a:extLst>
          </p:cNvPr>
          <p:cNvSpPr txBox="1"/>
          <p:nvPr/>
        </p:nvSpPr>
        <p:spPr>
          <a:xfrm>
            <a:off x="0" y="48049"/>
            <a:ext cx="118828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r>
              <a:rPr lang="ja-JP" altLang="en-US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Fig. </a:t>
            </a:r>
            <a:r>
              <a:rPr lang="en-US" sz="1800" b="1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Serum LRG levels in the PD and control groups following propensity score matching.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F98E99C1-AB22-4DB7-9DCE-AC0F396D1B96}"/>
              </a:ext>
            </a:extLst>
          </p:cNvPr>
          <p:cNvSpPr txBox="1"/>
          <p:nvPr/>
        </p:nvSpPr>
        <p:spPr>
          <a:xfrm>
            <a:off x="0" y="417381"/>
            <a:ext cx="12199110" cy="174900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Evaluations in</a:t>
            </a:r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30 pairs of PD and control groups matched using a propensity score matching approach, (A) Scatter plot of LRG levels. </a:t>
            </a:r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</a:t>
            </a:r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erum levels of LRG were statistically significantly higher in the PD group than in the control group (14.6 ± 4.9 μg/mL vs 12.3 ± 2.7 μg/mL, p = 0.019). </a:t>
            </a:r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</a:t>
            </a:r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-values generated by the Mann–Whitney U test are shown here. (B) Receiver operating characteristic curve analysis for diagnosis of PD by LRG levels. </a:t>
            </a:r>
          </a:p>
          <a:p>
            <a:pPr>
              <a:lnSpc>
                <a:spcPct val="200000"/>
              </a:lnSpc>
            </a:pPr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bbreviations: </a:t>
            </a:r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UROC, area under the receiver operating characteristic curve; Ctrl, controls; LRG, </a:t>
            </a:r>
            <a:r>
              <a:rPr lang="en-US" altLang="ja-JP" sz="1400" kern="100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l</a:t>
            </a:r>
            <a:r>
              <a:rPr lang="en-US" sz="14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eucine-rich α2 glycoprotein</a:t>
            </a:r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; PD, Parkinson’s disease.</a:t>
            </a:r>
            <a:endParaRPr lang="ja-JP" altLang="ja-JP" sz="14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graphicFrame>
        <p:nvGraphicFramePr>
          <p:cNvPr id="6" name="オブジェクト 5">
            <a:extLst>
              <a:ext uri="{FF2B5EF4-FFF2-40B4-BE49-F238E27FC236}">
                <a16:creationId xmlns:a16="http://schemas.microsoft.com/office/drawing/2014/main" id="{81E4F4DC-BE89-476C-BFD1-32837B72DAC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37334954"/>
              </p:ext>
            </p:extLst>
          </p:nvPr>
        </p:nvGraphicFramePr>
        <p:xfrm>
          <a:off x="5984875" y="2338388"/>
          <a:ext cx="4854575" cy="37353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3" imgW="3777824" imgH="2908964" progId="Prism6.Document">
                  <p:embed/>
                </p:oleObj>
              </mc:Choice>
              <mc:Fallback>
                <p:oleObj name="Prism 6" r:id="rId3" imgW="3777824" imgH="2908964" progId="Prism6.Document">
                  <p:embed/>
                  <p:pic>
                    <p:nvPicPr>
                      <p:cNvPr id="6" name="オブジェクト 5">
                        <a:extLst>
                          <a:ext uri="{FF2B5EF4-FFF2-40B4-BE49-F238E27FC236}">
                            <a16:creationId xmlns:a16="http://schemas.microsoft.com/office/drawing/2014/main" id="{81E4F4DC-BE89-476C-BFD1-32837B72DAC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984875" y="2338388"/>
                        <a:ext cx="4854575" cy="37353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オブジェクト 6">
            <a:extLst>
              <a:ext uri="{FF2B5EF4-FFF2-40B4-BE49-F238E27FC236}">
                <a16:creationId xmlns:a16="http://schemas.microsoft.com/office/drawing/2014/main" id="{12EB8C56-E392-4E29-ABF1-7F9EA3C2579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74738416"/>
              </p:ext>
            </p:extLst>
          </p:nvPr>
        </p:nvGraphicFramePr>
        <p:xfrm>
          <a:off x="615950" y="2371725"/>
          <a:ext cx="4852988" cy="35702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5" imgW="3924399" imgH="2884474" progId="Prism6.Document">
                  <p:embed/>
                </p:oleObj>
              </mc:Choice>
              <mc:Fallback>
                <p:oleObj name="Prism 6" r:id="rId5" imgW="3924399" imgH="2884474" progId="Prism6.Document">
                  <p:embed/>
                  <p:pic>
                    <p:nvPicPr>
                      <p:cNvPr id="7" name="オブジェクト 6">
                        <a:extLst>
                          <a:ext uri="{FF2B5EF4-FFF2-40B4-BE49-F238E27FC236}">
                            <a16:creationId xmlns:a16="http://schemas.microsoft.com/office/drawing/2014/main" id="{12EB8C56-E392-4E29-ABF1-7F9EA3C2579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15950" y="2371725"/>
                        <a:ext cx="4852988" cy="35702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134176668"/>
      </p:ext>
    </p:extLst>
  </p:cSld>
  <p:clrMapOvr>
    <a:masterClrMapping/>
  </p:clrMapOvr>
  <p:extLst>
    <p:ext uri="{6950BFC3-D8DA-4A85-94F7-54DA5524770B}">
      <p188:commentRel xmlns:p188="http://schemas.microsoft.com/office/powerpoint/2018/8/main" r:id="rId2"/>
    </p:ext>
  </p:extLst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916</TotalTime>
  <Words>135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Office テーマ</vt:lpstr>
      <vt:lpstr>Prism 6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卓摩 大道</dc:creator>
  <cp:lastModifiedBy>chn off28</cp:lastModifiedBy>
  <cp:revision>28</cp:revision>
  <dcterms:created xsi:type="dcterms:W3CDTF">2021-06-23T16:38:15Z</dcterms:created>
  <dcterms:modified xsi:type="dcterms:W3CDTF">2023-02-14T19:51:52Z</dcterms:modified>
</cp:coreProperties>
</file>